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75" r:id="rId2"/>
    <p:sldId id="272" r:id="rId3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-1692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2152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4A47AC-1503-4D1E-BF0D-5A54C93634B2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876109C-E824-4F70-ABCE-35EB5E1770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318947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5560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809232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716048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50189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771328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770111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826639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96738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725406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252995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828934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916807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jpeg"/><Relationship Id="rId3" Type="http://schemas.openxmlformats.org/officeDocument/2006/relationships/image" Target="../media/image10.jpeg"/><Relationship Id="rId7" Type="http://schemas.openxmlformats.org/officeDocument/2006/relationships/image" Target="../media/image13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5" Type="http://schemas.openxmlformats.org/officeDocument/2006/relationships/image" Target="../media/image12.jpeg"/><Relationship Id="rId10" Type="http://schemas.openxmlformats.org/officeDocument/2006/relationships/image" Target="../media/image16.jpeg"/><Relationship Id="rId4" Type="http://schemas.openxmlformats.org/officeDocument/2006/relationships/image" Target="../media/image11.jpeg"/><Relationship Id="rId9" Type="http://schemas.openxmlformats.org/officeDocument/2006/relationships/image" Target="../media/image1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927835" y="1055207"/>
            <a:ext cx="13681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Caspase-8</a:t>
            </a:r>
            <a:endParaRPr lang="hsb-DE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289424" y="1532915"/>
            <a:ext cx="18722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Cleaved Caspase-8</a:t>
            </a:r>
          </a:p>
        </p:txBody>
      </p:sp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91931" y="1030041"/>
            <a:ext cx="3140074" cy="4447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4" name="Picture 6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91931" y="1532915"/>
            <a:ext cx="3140075" cy="523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5" name="TextBox 34"/>
          <p:cNvSpPr txBox="1"/>
          <p:nvPr/>
        </p:nvSpPr>
        <p:spPr>
          <a:xfrm>
            <a:off x="1899558" y="3359992"/>
            <a:ext cx="13681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Caspase-7</a:t>
            </a:r>
            <a:endParaRPr lang="hsb-DE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1269293" y="3950345"/>
            <a:ext cx="18722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Cleaved Caspase-7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1907704" y="2191314"/>
            <a:ext cx="13681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Caspase-3</a:t>
            </a:r>
            <a:endParaRPr lang="hsb-DE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1295636" y="2741500"/>
            <a:ext cx="18722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Cleaved Caspase-3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2195736" y="4670425"/>
            <a:ext cx="13681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PARP</a:t>
            </a:r>
            <a:endParaRPr lang="hsb-DE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5868144" y="2786988"/>
            <a:ext cx="2160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dirty="0" smtClean="0">
                <a:latin typeface="Times New Roman" pitchFamily="18" charset="0"/>
                <a:cs typeface="Times New Roman" pitchFamily="18" charset="0"/>
              </a:rPr>
              <a:t>}</a:t>
            </a:r>
            <a:endParaRPr lang="ko-KR" altLang="en-US" sz="20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91931" y="3867048"/>
            <a:ext cx="3140075" cy="49758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9" name="TextBox 28"/>
          <p:cNvSpPr txBox="1"/>
          <p:nvPr/>
        </p:nvSpPr>
        <p:spPr>
          <a:xfrm>
            <a:off x="3760590" y="588701"/>
            <a:ext cx="17475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itchFamily="18" charset="0"/>
                <a:cs typeface="Times New Roman" pitchFamily="18" charset="0"/>
              </a:rPr>
              <a:t>LPS 246</a:t>
            </a:r>
            <a:endParaRPr lang="ko-KR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" name="직사각형 29"/>
          <p:cNvSpPr/>
          <p:nvPr/>
        </p:nvSpPr>
        <p:spPr>
          <a:xfrm>
            <a:off x="-3425" y="-15231"/>
            <a:ext cx="8197244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2000" b="1" dirty="0">
                <a:latin typeface="Times New Roman" pitchFamily="18" charset="0"/>
                <a:cs typeface="Times New Roman" pitchFamily="18" charset="0"/>
              </a:rPr>
              <a:t>Supplementary Fig. 5. Effect of PF and TRAIL co-treatment on apoptosis</a:t>
            </a:r>
            <a:endParaRPr lang="ko-KR" altLang="en-US" sz="2000" dirty="0"/>
          </a:p>
        </p:txBody>
      </p:sp>
      <p:sp>
        <p:nvSpPr>
          <p:cNvPr id="31" name="TextBox 30"/>
          <p:cNvSpPr txBox="1"/>
          <p:nvPr/>
        </p:nvSpPr>
        <p:spPr>
          <a:xfrm>
            <a:off x="6012160" y="1102049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52kDa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6012160" y="1551856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41kDa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6012160" y="2199928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35kDa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6012160" y="2861543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18kDa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6012160" y="3388351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37kDa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6012160" y="3906696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20kDa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2123728" y="5638856"/>
            <a:ext cx="392091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TRAIL       -          +        -       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+ </a:t>
            </a:r>
            <a:r>
              <a:rPr lang="en-US" altLang="ko-KR" sz="900" dirty="0">
                <a:latin typeface="Times New Roman" pitchFamily="18" charset="0"/>
                <a:cs typeface="Times New Roman" pitchFamily="18" charset="0"/>
              </a:rPr>
              <a:t>(2)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      +         + </a:t>
            </a:r>
            <a:r>
              <a:rPr lang="en-US" altLang="ko-KR" sz="900" dirty="0">
                <a:latin typeface="Times New Roman" pitchFamily="18" charset="0"/>
                <a:cs typeface="Times New Roman" pitchFamily="18" charset="0"/>
              </a:rPr>
              <a:t>(1)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 </a:t>
            </a:r>
          </a:p>
          <a:p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PF              -          -         +       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 + </a:t>
            </a:r>
            <a:r>
              <a:rPr lang="en-US" altLang="ko-KR" sz="900" dirty="0">
                <a:latin typeface="Times New Roman" pitchFamily="18" charset="0"/>
                <a:cs typeface="Times New Roman" pitchFamily="18" charset="0"/>
              </a:rPr>
              <a:t>(1)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      +         + </a:t>
            </a:r>
            <a:r>
              <a:rPr lang="en-US" altLang="ko-KR" sz="900" dirty="0">
                <a:latin typeface="Times New Roman" pitchFamily="18" charset="0"/>
                <a:cs typeface="Times New Roman" pitchFamily="18" charset="0"/>
              </a:rPr>
              <a:t>(2)</a:t>
            </a:r>
            <a:endParaRPr lang="ko-KR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1776905" y="583184"/>
            <a:ext cx="34682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4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ko-KR" altLang="ko-KR" sz="2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2139630" y="5206227"/>
            <a:ext cx="13681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ACTB</a:t>
            </a:r>
            <a:endParaRPr lang="hsb-DE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6010084" y="5206226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42kDa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6084168" y="4487696"/>
            <a:ext cx="7920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116kDa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6084168" y="4670895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89kDa</a:t>
            </a:r>
          </a:p>
        </p:txBody>
      </p:sp>
      <p:cxnSp>
        <p:nvCxnSpPr>
          <p:cNvPr id="52" name="직선 화살표 연결선 51"/>
          <p:cNvCxnSpPr/>
          <p:nvPr/>
        </p:nvCxnSpPr>
        <p:spPr>
          <a:xfrm>
            <a:off x="5940152" y="4651457"/>
            <a:ext cx="208983" cy="0"/>
          </a:xfrm>
          <a:prstGeom prst="straightConnector1">
            <a:avLst/>
          </a:prstGeom>
          <a:ln w="25400">
            <a:solidFill>
              <a:schemeClr val="tx1"/>
            </a:solidFill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직선 화살표 연결선 52"/>
          <p:cNvCxnSpPr/>
          <p:nvPr/>
        </p:nvCxnSpPr>
        <p:spPr>
          <a:xfrm>
            <a:off x="5940152" y="4823030"/>
            <a:ext cx="208983" cy="0"/>
          </a:xfrm>
          <a:prstGeom prst="straightConnector1">
            <a:avLst/>
          </a:prstGeom>
          <a:ln w="25400">
            <a:solidFill>
              <a:schemeClr val="tx1"/>
            </a:solidFill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90955" y="2082353"/>
            <a:ext cx="3141050" cy="542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91931" y="2674642"/>
            <a:ext cx="3140074" cy="5675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90955" y="4415688"/>
            <a:ext cx="3141050" cy="5958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" name="Picture 5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97740" y="5068817"/>
            <a:ext cx="3134265" cy="5106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97740" y="3293492"/>
            <a:ext cx="3134265" cy="5079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0805384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77798" y="4739648"/>
            <a:ext cx="3170232" cy="57018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60370" y="1826982"/>
            <a:ext cx="3195806" cy="44989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1" name="Picture 17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77798" y="1268760"/>
            <a:ext cx="3177556" cy="5095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8" name="Picture 10"/>
          <p:cNvPicPr>
            <a:picLocks noChangeAspect="1" noChangeArrowheads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60370" y="3505002"/>
            <a:ext cx="3187661" cy="5000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60370" y="4051419"/>
            <a:ext cx="3187661" cy="6334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7" name="직사각형 26"/>
          <p:cNvSpPr/>
          <p:nvPr/>
        </p:nvSpPr>
        <p:spPr>
          <a:xfrm>
            <a:off x="-4936" y="0"/>
            <a:ext cx="898765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2000" b="1" dirty="0">
                <a:latin typeface="Times New Roman" pitchFamily="18" charset="0"/>
                <a:cs typeface="Times New Roman" pitchFamily="18" charset="0"/>
              </a:rPr>
              <a:t>Supplementary Fig. </a:t>
            </a:r>
            <a:r>
              <a:rPr lang="en-US" altLang="ko-KR" sz="2000" b="1" dirty="0" smtClean="0">
                <a:latin typeface="Times New Roman" pitchFamily="18" charset="0"/>
                <a:cs typeface="Times New Roman" pitchFamily="18" charset="0"/>
              </a:rPr>
              <a:t>5</a:t>
            </a:r>
            <a:endParaRPr lang="en-US" altLang="ko-KR" sz="2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904606" y="749895"/>
            <a:ext cx="17475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itchFamily="18" charset="0"/>
                <a:cs typeface="Times New Roman" pitchFamily="18" charset="0"/>
              </a:rPr>
              <a:t>11GS079</a:t>
            </a:r>
            <a:endParaRPr lang="ko-KR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2071851" y="1394293"/>
            <a:ext cx="13681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Caspase-8</a:t>
            </a:r>
            <a:endParaRPr lang="hsb-DE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1433440" y="1906505"/>
            <a:ext cx="18722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Cleaved Caspase-8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2043574" y="3573016"/>
            <a:ext cx="13681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Caspase-7</a:t>
            </a:r>
            <a:endParaRPr lang="hsb-DE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1413309" y="4201343"/>
            <a:ext cx="18722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Cleaved Caspase-7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2051720" y="2420888"/>
            <a:ext cx="13681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Caspase-3</a:t>
            </a:r>
            <a:endParaRPr lang="hsb-DE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1439652" y="2996952"/>
            <a:ext cx="18722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Cleaved Caspase-3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2339752" y="4779900"/>
            <a:ext cx="13681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PARP</a:t>
            </a:r>
            <a:endParaRPr lang="hsb-DE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6084168" y="2852936"/>
            <a:ext cx="2160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dirty="0" smtClean="0">
                <a:latin typeface="Times New Roman" pitchFamily="18" charset="0"/>
                <a:cs typeface="Times New Roman" pitchFamily="18" charset="0"/>
              </a:rPr>
              <a:t>}</a:t>
            </a:r>
            <a:endParaRPr lang="ko-KR" altLang="en-US" sz="2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6228184" y="1369127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52kDa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6228184" y="1853438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41kDa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6228184" y="2501510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35kDa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6228184" y="2927491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18kDa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6228184" y="3429000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37kDa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6228184" y="4345359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20kDa</a:t>
            </a:r>
          </a:p>
        </p:txBody>
      </p:sp>
      <p:cxnSp>
        <p:nvCxnSpPr>
          <p:cNvPr id="57" name="직선 화살표 연결선 56"/>
          <p:cNvCxnSpPr/>
          <p:nvPr/>
        </p:nvCxnSpPr>
        <p:spPr>
          <a:xfrm>
            <a:off x="6091209" y="3573016"/>
            <a:ext cx="208983" cy="0"/>
          </a:xfrm>
          <a:prstGeom prst="straightConnector1">
            <a:avLst/>
          </a:prstGeom>
          <a:ln w="25400">
            <a:solidFill>
              <a:schemeClr val="tx1"/>
            </a:solidFill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직선 화살표 연결선 57"/>
          <p:cNvCxnSpPr/>
          <p:nvPr/>
        </p:nvCxnSpPr>
        <p:spPr>
          <a:xfrm>
            <a:off x="6091209" y="4500494"/>
            <a:ext cx="208983" cy="0"/>
          </a:xfrm>
          <a:prstGeom prst="straightConnector1">
            <a:avLst/>
          </a:prstGeom>
          <a:ln w="25400">
            <a:solidFill>
              <a:schemeClr val="tx1"/>
            </a:solidFill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/>
          <p:cNvSpPr txBox="1"/>
          <p:nvPr/>
        </p:nvSpPr>
        <p:spPr>
          <a:xfrm>
            <a:off x="2452987" y="5788012"/>
            <a:ext cx="384720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TRAIL       -          +        -        + </a:t>
            </a:r>
            <a:r>
              <a:rPr lang="en-US" altLang="ko-KR" sz="900" dirty="0" smtClean="0">
                <a:latin typeface="Times New Roman" pitchFamily="18" charset="0"/>
                <a:cs typeface="Times New Roman" pitchFamily="18" charset="0"/>
              </a:rPr>
              <a:t>(2)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      +         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+ </a:t>
            </a:r>
            <a:r>
              <a:rPr lang="en-US" altLang="ko-KR" sz="900" dirty="0" smtClean="0">
                <a:latin typeface="Times New Roman" pitchFamily="18" charset="0"/>
                <a:cs typeface="Times New Roman" pitchFamily="18" charset="0"/>
              </a:rPr>
              <a:t>(1)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 </a:t>
            </a:r>
          </a:p>
          <a:p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PF              -          -         +       + </a:t>
            </a:r>
            <a:r>
              <a:rPr lang="en-US" altLang="ko-KR" sz="900" dirty="0" smtClean="0">
                <a:latin typeface="Times New Roman" pitchFamily="18" charset="0"/>
                <a:cs typeface="Times New Roman" pitchFamily="18" charset="0"/>
              </a:rPr>
              <a:t>(1)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      +         + </a:t>
            </a:r>
            <a:r>
              <a:rPr lang="en-US" altLang="ko-KR" sz="900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altLang="ko-KR" sz="900" dirty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altLang="ko-KR" sz="900" dirty="0" smtClean="0">
                <a:latin typeface="Times New Roman" pitchFamily="18" charset="0"/>
                <a:cs typeface="Times New Roman" pitchFamily="18" charset="0"/>
              </a:rPr>
              <a:t>)</a:t>
            </a:r>
            <a:endParaRPr lang="ko-KR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1776905" y="476672"/>
            <a:ext cx="34682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4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ko-KR" altLang="ko-KR" sz="24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40038" y="5355964"/>
            <a:ext cx="3207993" cy="4320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8" name="TextBox 37"/>
          <p:cNvSpPr txBox="1"/>
          <p:nvPr/>
        </p:nvSpPr>
        <p:spPr>
          <a:xfrm>
            <a:off x="2339752" y="5408227"/>
            <a:ext cx="13681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ACTB</a:t>
            </a:r>
            <a:endParaRPr lang="hsb-DE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6228184" y="5408226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42kDa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6228184" y="4832163"/>
            <a:ext cx="7920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116kDa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6213965" y="4976179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89kDa</a:t>
            </a:r>
          </a:p>
        </p:txBody>
      </p:sp>
      <p:cxnSp>
        <p:nvCxnSpPr>
          <p:cNvPr id="49" name="직선 화살표 연결선 48"/>
          <p:cNvCxnSpPr/>
          <p:nvPr/>
        </p:nvCxnSpPr>
        <p:spPr>
          <a:xfrm>
            <a:off x="6084168" y="4995924"/>
            <a:ext cx="208983" cy="0"/>
          </a:xfrm>
          <a:prstGeom prst="straightConnector1">
            <a:avLst/>
          </a:prstGeom>
          <a:ln w="25400">
            <a:solidFill>
              <a:schemeClr val="tx1"/>
            </a:solidFill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직선 화살표 연결선 49"/>
          <p:cNvCxnSpPr/>
          <p:nvPr/>
        </p:nvCxnSpPr>
        <p:spPr>
          <a:xfrm>
            <a:off x="6084168" y="5139940"/>
            <a:ext cx="208983" cy="0"/>
          </a:xfrm>
          <a:prstGeom prst="straightConnector1">
            <a:avLst/>
          </a:prstGeom>
          <a:ln w="25400">
            <a:solidFill>
              <a:schemeClr val="tx1"/>
            </a:solidFill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60369" y="2878157"/>
            <a:ext cx="3187661" cy="5508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60370" y="2341413"/>
            <a:ext cx="3187660" cy="4667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918301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 w="2540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452</TotalTime>
  <Words>116</Words>
  <Application>Microsoft Office PowerPoint</Application>
  <PresentationFormat>화면 슬라이드 쇼(4:3)</PresentationFormat>
  <Paragraphs>46</Paragraphs>
  <Slides>2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3" baseType="lpstr">
      <vt:lpstr>Office 테마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TRC 홍두표</dc:creator>
  <cp:lastModifiedBy>홍성민</cp:lastModifiedBy>
  <cp:revision>64</cp:revision>
  <dcterms:created xsi:type="dcterms:W3CDTF">2018-11-08T23:08:45Z</dcterms:created>
  <dcterms:modified xsi:type="dcterms:W3CDTF">2019-04-07T14:26:4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NSCPROP">
    <vt:lpwstr>NSCCustomProperty</vt:lpwstr>
  </property>
  <property fmtid="{D5CDD505-2E9C-101B-9397-08002B2CF9AE}" pid="3" name="NSCPROP_SA">
    <vt:lpwstr>D:\홍두표 박사님\메추라기\Mouse sarcoma model\PDX\trail cmet figure\revision\BCAND18 REVISION 181109.pptx</vt:lpwstr>
  </property>
</Properties>
</file>